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954838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-72" y="3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9466" y="0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r">
              <a:defRPr sz="1200"/>
            </a:lvl1pPr>
          </a:lstStyle>
          <a:p>
            <a:fld id="{010AD683-7A80-4731-996F-DCF8FABE9119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698500"/>
            <a:ext cx="4652962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30" tIns="46465" rIns="92930" bIns="46465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484" y="4421823"/>
            <a:ext cx="5563870" cy="4189095"/>
          </a:xfrm>
          <a:prstGeom prst="rect">
            <a:avLst/>
          </a:prstGeom>
        </p:spPr>
        <p:txBody>
          <a:bodyPr vert="horz" lIns="92930" tIns="46465" rIns="92930" bIns="4646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9466" y="8842029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r">
              <a:defRPr sz="1200"/>
            </a:lvl1pPr>
          </a:lstStyle>
          <a:p>
            <a:fld id="{E9C6C54A-F6D3-4976-872B-FFA1A501D17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66422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799459-F5CA-4023-A9DB-8D614ECAC179}" type="slidenum">
              <a:rPr lang="en-CA" smtClean="0"/>
              <a:pPr/>
              <a:t>1</a:t>
            </a:fld>
            <a:endParaRPr lang="en-CA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E9065-69DF-4809-99AA-69EBC80E0C82}" type="datetimeFigureOut">
              <a:rPr lang="en-CA" smtClean="0"/>
              <a:pPr/>
              <a:t>28/04/20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38E00-83CE-45DF-A19A-56CA6B34C043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3" name="Straight Connector 32"/>
          <p:cNvCxnSpPr/>
          <p:nvPr/>
        </p:nvCxnSpPr>
        <p:spPr>
          <a:xfrm>
            <a:off x="460985" y="4422393"/>
            <a:ext cx="541956" cy="0"/>
          </a:xfrm>
          <a:prstGeom prst="line">
            <a:avLst/>
          </a:prstGeom>
          <a:ln w="1905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7" name="Group 74"/>
          <p:cNvGrpSpPr/>
          <p:nvPr/>
        </p:nvGrpSpPr>
        <p:grpSpPr>
          <a:xfrm>
            <a:off x="1100730" y="482960"/>
            <a:ext cx="8049367" cy="4994843"/>
            <a:chOff x="1576741" y="987785"/>
            <a:chExt cx="8501529" cy="4994843"/>
          </a:xfrm>
        </p:grpSpPr>
        <p:sp>
          <p:nvSpPr>
            <p:cNvPr id="55" name="TextBox 54"/>
            <p:cNvSpPr txBox="1"/>
            <p:nvPr/>
          </p:nvSpPr>
          <p:spPr>
            <a:xfrm>
              <a:off x="1576741" y="987785"/>
              <a:ext cx="233844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magna -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KF419217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2247553" y="1304392"/>
              <a:ext cx="36370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dispersa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(</a:t>
              </a:r>
              <a:r>
                <a:rPr lang="en-CA" sz="1400" dirty="0" err="1" smtClean="0">
                  <a:latin typeface="Times New Roman" pitchFamily="18" charset="0"/>
                  <a:cs typeface="Times New Roman" pitchFamily="18" charset="0"/>
                </a:rPr>
                <a:t>Briston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 strain) -</a:t>
              </a:r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KJ608416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3306321" y="1615921"/>
              <a:ext cx="271429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acervulina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 - HQ702479</a:t>
              </a:r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3465351" y="1935025"/>
              <a:ext cx="246711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praecox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HQ702483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4156484" y="2234158"/>
              <a:ext cx="245526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brunetti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HQ702480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5694471" y="2539347"/>
              <a:ext cx="250266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maxima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HQ702481</a:t>
              </a:r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3901148" y="2862125"/>
              <a:ext cx="353881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mitis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(USDA50 strain)</a:t>
              </a:r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KF501573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3896951" y="3169956"/>
              <a:ext cx="216067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mitis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JN864949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7" name="Rectangle 66"/>
            <p:cNvSpPr/>
            <p:nvPr/>
          </p:nvSpPr>
          <p:spPr>
            <a:xfrm>
              <a:off x="3461582" y="3499206"/>
              <a:ext cx="252467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necatrix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HQ702482 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8" name="Rectangle 67"/>
            <p:cNvSpPr/>
            <p:nvPr/>
          </p:nvSpPr>
          <p:spPr>
            <a:xfrm>
              <a:off x="3357770" y="3803881"/>
              <a:ext cx="241801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tenella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HQ702484</a:t>
              </a:r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3361970" y="4100220"/>
              <a:ext cx="346574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tenella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(NAIH strain)- AB564272</a:t>
              </a:r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0" name="Rectangle 69"/>
            <p:cNvSpPr/>
            <p:nvPr/>
          </p:nvSpPr>
          <p:spPr>
            <a:xfrm>
              <a:off x="5562569" y="4432303"/>
              <a:ext cx="451570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meleagrimitis </a:t>
              </a:r>
              <a:r>
                <a:rPr lang="en-CA" sz="1400" smtClean="0">
                  <a:latin typeface="Times New Roman" pitchFamily="18" charset="0"/>
                  <a:cs typeface="Times New Roman" pitchFamily="18" charset="0"/>
                </a:rPr>
                <a:t>(USMN08-01 strain)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KJ608414</a:t>
              </a:r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3337012" y="5060268"/>
              <a:ext cx="42414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gallopavonis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(Weybridge strain) - KJ608413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3356062" y="4736604"/>
              <a:ext cx="4434435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</a:t>
              </a:r>
              <a:r>
                <a:rPr lang="en-CA" sz="1400" i="1" smtClean="0">
                  <a:latin typeface="Times New Roman" pitchFamily="18" charset="0"/>
                  <a:cs typeface="Times New Roman" pitchFamily="18" charset="0"/>
                </a:rPr>
                <a:t>gallopavonis</a:t>
              </a:r>
              <a:r>
                <a:rPr lang="en-CA" sz="1400" smtClean="0">
                  <a:latin typeface="Times New Roman" pitchFamily="18" charset="0"/>
                  <a:cs typeface="Times New Roman" pitchFamily="18" charset="0"/>
                </a:rPr>
                <a:t>  (USKS06-01 strain)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KJ608417</a:t>
              </a:r>
              <a:br>
                <a:rPr lang="en-CA" sz="1400" dirty="0" smtClean="0">
                  <a:latin typeface="Times New Roman" pitchFamily="18" charset="0"/>
                  <a:cs typeface="Times New Roman" pitchFamily="18" charset="0"/>
                </a:rPr>
              </a:b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3401591" y="5386819"/>
              <a:ext cx="3846948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adenoeides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(Guelph strain) - KJ608415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370920" y="5674851"/>
              <a:ext cx="432608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CA" sz="1400" i="1" dirty="0" smtClean="0">
                  <a:latin typeface="Times New Roman" pitchFamily="18" charset="0"/>
                  <a:cs typeface="Times New Roman" pitchFamily="18" charset="0"/>
                </a:rPr>
                <a:t>Eimeria </a:t>
              </a:r>
              <a:r>
                <a:rPr lang="en-CA" sz="1400" i="1" smtClean="0">
                  <a:latin typeface="Times New Roman" pitchFamily="18" charset="0"/>
                  <a:cs typeface="Times New Roman" pitchFamily="18" charset="0"/>
                </a:rPr>
                <a:t>meleagridis</a:t>
              </a:r>
              <a:r>
                <a:rPr lang="en-CA" sz="1400" smtClean="0">
                  <a:latin typeface="Times New Roman" pitchFamily="18" charset="0"/>
                  <a:cs typeface="Times New Roman" pitchFamily="18" charset="0"/>
                </a:rPr>
                <a:t> (USAR97-01 strain) </a:t>
              </a:r>
              <a:r>
                <a:rPr lang="en-CA" sz="1400" dirty="0" smtClean="0">
                  <a:latin typeface="Times New Roman" pitchFamily="18" charset="0"/>
                  <a:cs typeface="Times New Roman" pitchFamily="18" charset="0"/>
                </a:rPr>
                <a:t>- KJ608418</a:t>
              </a:r>
              <a:endParaRPr lang="en-CA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48" name="Group 81"/>
          <p:cNvGrpSpPr/>
          <p:nvPr/>
        </p:nvGrpSpPr>
        <p:grpSpPr>
          <a:xfrm>
            <a:off x="1253807" y="1644650"/>
            <a:ext cx="1944879" cy="3697570"/>
            <a:chOff x="1558607" y="2149475"/>
            <a:chExt cx="1944879" cy="3697570"/>
          </a:xfrm>
        </p:grpSpPr>
        <p:sp>
          <p:nvSpPr>
            <p:cNvPr id="87" name="TextBox 86"/>
            <p:cNvSpPr txBox="1"/>
            <p:nvPr/>
          </p:nvSpPr>
          <p:spPr>
            <a:xfrm>
              <a:off x="2070388" y="2149475"/>
              <a:ext cx="23724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100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558607" y="3303203"/>
              <a:ext cx="23724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100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026872" y="4456849"/>
              <a:ext cx="23724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100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093468" y="2512628"/>
              <a:ext cx="315792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0.86/41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615102" y="2733944"/>
              <a:ext cx="31579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0.55/21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3266242" y="3209074"/>
              <a:ext cx="23724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100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639344" y="3915044"/>
              <a:ext cx="23724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100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746360" y="4148687"/>
              <a:ext cx="23724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100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060971" y="5012100"/>
              <a:ext cx="31579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0.59/45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773744" y="5095584"/>
              <a:ext cx="23724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100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446935" y="5403185"/>
              <a:ext cx="184345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99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2627349" y="5708546"/>
              <a:ext cx="184345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en-CA" sz="900" b="1" dirty="0" smtClean="0">
                  <a:latin typeface="Arial Narrow" panose="020B0606020202030204" pitchFamily="34" charset="0"/>
                  <a:cs typeface="Times New Roman" pitchFamily="18" charset="0"/>
                </a:rPr>
                <a:t>1/95</a:t>
              </a:r>
              <a:endParaRPr lang="en-CA" sz="900" b="1" dirty="0">
                <a:latin typeface="Arial Narrow" panose="020B0606020202030204" pitchFamily="34" charset="0"/>
                <a:cs typeface="Times New Roman" pitchFamily="18" charset="0"/>
              </a:endParaRPr>
            </a:p>
          </p:txBody>
        </p:sp>
      </p:grpSp>
      <p:cxnSp>
        <p:nvCxnSpPr>
          <p:cNvPr id="2" name="Straight Connector 1"/>
          <p:cNvCxnSpPr/>
          <p:nvPr/>
        </p:nvCxnSpPr>
        <p:spPr>
          <a:xfrm flipV="1">
            <a:off x="357861" y="651278"/>
            <a:ext cx="687299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 flipV="1">
            <a:off x="1518058" y="1616557"/>
            <a:ext cx="511280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3"/>
          <p:cNvCxnSpPr/>
          <p:nvPr/>
        </p:nvCxnSpPr>
        <p:spPr>
          <a:xfrm>
            <a:off x="1036092" y="970525"/>
            <a:ext cx="647621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V="1">
            <a:off x="2036571" y="1267221"/>
            <a:ext cx="647621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2593210" y="3627686"/>
            <a:ext cx="102256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2593210" y="3150070"/>
            <a:ext cx="238597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2130982" y="1597731"/>
            <a:ext cx="715791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V="1">
            <a:off x="2329421" y="1902240"/>
            <a:ext cx="1158900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V="1">
            <a:off x="2131016" y="2355780"/>
            <a:ext cx="61151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V="1">
            <a:off x="2354201" y="4568546"/>
            <a:ext cx="370746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V="1">
            <a:off x="2331677" y="2208882"/>
            <a:ext cx="2624568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2102203" y="4090507"/>
            <a:ext cx="2726824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985712" y="3392226"/>
            <a:ext cx="604800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V="1">
            <a:off x="2192167" y="2051957"/>
            <a:ext cx="135162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2040171" y="1985976"/>
            <a:ext cx="90000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2707538" y="3468845"/>
            <a:ext cx="34085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2099086" y="4868109"/>
            <a:ext cx="238597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1988270" y="4474616"/>
            <a:ext cx="102256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357613" y="1867848"/>
            <a:ext cx="675145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1037568" y="2777870"/>
            <a:ext cx="468004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1518252" y="3930650"/>
            <a:ext cx="461046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H="1">
            <a:off x="353162" y="656065"/>
            <a:ext cx="0" cy="1200648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 flipV="1">
            <a:off x="1036050" y="974114"/>
            <a:ext cx="0" cy="180000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V="1">
            <a:off x="1518005" y="1621913"/>
            <a:ext cx="0" cy="230400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V="1">
            <a:off x="2035187" y="1273163"/>
            <a:ext cx="0" cy="703432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V="1">
            <a:off x="2127971" y="1597273"/>
            <a:ext cx="0" cy="75600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V="1">
            <a:off x="3219671" y="2531893"/>
            <a:ext cx="0" cy="298811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V="1">
            <a:off x="2192167" y="2056981"/>
            <a:ext cx="0" cy="617975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2329669" y="1904194"/>
            <a:ext cx="0" cy="302418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1982213" y="3390899"/>
            <a:ext cx="0" cy="108000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2593210" y="3154344"/>
            <a:ext cx="0" cy="46800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2192167" y="2679979"/>
            <a:ext cx="1017774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2706939" y="3766352"/>
            <a:ext cx="34085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/>
          <p:cNvCxnSpPr/>
          <p:nvPr/>
        </p:nvCxnSpPr>
        <p:spPr>
          <a:xfrm flipV="1">
            <a:off x="2705940" y="3468958"/>
            <a:ext cx="0" cy="28800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H="1">
            <a:off x="2096929" y="4090463"/>
            <a:ext cx="0" cy="779987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2358369" y="5181076"/>
            <a:ext cx="170427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3223358" y="2835927"/>
            <a:ext cx="34085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221447" y="2529019"/>
            <a:ext cx="34085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V="1">
            <a:off x="2353904" y="4569070"/>
            <a:ext cx="0" cy="60290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 flipV="1">
            <a:off x="2729704" y="4403271"/>
            <a:ext cx="0" cy="326572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flipV="1">
            <a:off x="2529912" y="5044275"/>
            <a:ext cx="243651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2529911" y="5046366"/>
            <a:ext cx="0" cy="296426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2529911" y="5350107"/>
            <a:ext cx="204512" cy="0"/>
          </a:xfrm>
          <a:prstGeom prst="line">
            <a:avLst/>
          </a:prstGeom>
          <a:ln w="25400" cap="rnd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515963" y="4429125"/>
            <a:ext cx="432000" cy="230832"/>
          </a:xfrm>
          <a:prstGeom prst="rect">
            <a:avLst/>
          </a:prstGeom>
          <a:noFill/>
          <a:ln w="25400" cap="rnd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900" b="1" dirty="0" smtClean="0">
                <a:latin typeface="Times New Roman" pitchFamily="18" charset="0"/>
                <a:cs typeface="Times New Roman" pitchFamily="18" charset="0"/>
              </a:rPr>
              <a:t>0.05</a:t>
            </a:r>
            <a:endParaRPr lang="en-CA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031801" y="6581001"/>
            <a:ext cx="3112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smtClean="0">
                <a:latin typeface="Times New Roman" pitchFamily="18" charset="0"/>
                <a:cs typeface="Times New Roman" pitchFamily="18" charset="0"/>
              </a:rPr>
              <a:t>Ogedengbe </a:t>
            </a:r>
            <a:r>
              <a:rPr lang="en-CA" sz="1200" b="1">
                <a:latin typeface="Times New Roman" pitchFamily="18" charset="0"/>
                <a:cs typeface="Times New Roman" pitchFamily="18" charset="0"/>
              </a:rPr>
              <a:t>et </a:t>
            </a:r>
            <a:r>
              <a:rPr lang="en-CA" sz="1200" b="1" smtClean="0">
                <a:latin typeface="Times New Roman" pitchFamily="18" charset="0"/>
                <a:cs typeface="Times New Roman" pitchFamily="18" charset="0"/>
              </a:rPr>
              <a:t>al. – Supplementary Figure S1</a:t>
            </a:r>
            <a:endParaRPr lang="en-CA" sz="12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9" name="Straight Arrow Connector 48"/>
          <p:cNvCxnSpPr/>
          <p:nvPr/>
        </p:nvCxnSpPr>
        <p:spPr>
          <a:xfrm flipH="1" flipV="1">
            <a:off x="2235573" y="2070847"/>
            <a:ext cx="54558" cy="163649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17</Words>
  <Application>Microsoft Office PowerPoint</Application>
  <PresentationFormat>On-screen Show (4:3)</PresentationFormat>
  <Paragraphs>3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ossy</dc:creator>
  <cp:lastModifiedBy>John R Barta</cp:lastModifiedBy>
  <cp:revision>6</cp:revision>
  <dcterms:created xsi:type="dcterms:W3CDTF">2014-04-08T18:41:07Z</dcterms:created>
  <dcterms:modified xsi:type="dcterms:W3CDTF">2014-04-28T16:59:07Z</dcterms:modified>
</cp:coreProperties>
</file>